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3"/>
  </p:notesMasterIdLst>
  <p:sldIdLst>
    <p:sldId id="342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400" userDrawn="1">
          <p15:clr>
            <a:srgbClr val="A4A3A4"/>
          </p15:clr>
        </p15:guide>
        <p15:guide id="2" pos="74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4300"/>
    <a:srgbClr val="C09100"/>
    <a:srgbClr val="2973B9"/>
    <a:srgbClr val="C89A00"/>
    <a:srgbClr val="F14900"/>
    <a:srgbClr val="E14403"/>
    <a:srgbClr val="2B81C2"/>
    <a:srgbClr val="F9DD00"/>
    <a:srgbClr val="FA5A06"/>
    <a:srgbClr val="43C7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211"/>
    <p:restoredTop sz="88689"/>
  </p:normalViewPr>
  <p:slideViewPr>
    <p:cSldViewPr snapToGrid="0" snapToObjects="1" showGuides="1">
      <p:cViewPr varScale="1">
        <p:scale>
          <a:sx n="61" d="100"/>
          <a:sy n="61" d="100"/>
        </p:scale>
        <p:origin x="2952" y="200"/>
      </p:cViewPr>
      <p:guideLst>
        <p:guide orient="horz" pos="5400"/>
        <p:guide pos="744"/>
      </p:guideLst>
    </p:cSldViewPr>
  </p:slideViewPr>
  <p:notesTextViewPr>
    <p:cViewPr>
      <p:scale>
        <a:sx n="85" d="100"/>
        <a:sy n="85" d="100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FF69FB2-9E77-AE40-9402-CD320D8F420A}" type="datetimeFigureOut">
              <a:rPr lang="en-US" smtClean="0"/>
              <a:t>12/3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D53D5EE-7DDF-084A-A8E6-F948496FBDE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47454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sz="1200" cap="none" dirty="0">
              <a:latin typeface="Apple Braille" charset="0"/>
              <a:ea typeface="Apple Braille" charset="0"/>
              <a:cs typeface="Apple Braille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D53D5EE-7DDF-084A-A8E6-F948496FBDE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315894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F2D40D-6BD3-C945-947A-7A9161E2C661}" type="datetimeFigureOut">
              <a:rPr lang="en-US" smtClean="0"/>
              <a:t>12/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8B623-3C3F-C345-8EE9-785364D7CF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97031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F2D40D-6BD3-C945-947A-7A9161E2C661}" type="datetimeFigureOut">
              <a:rPr lang="en-US" smtClean="0"/>
              <a:t>12/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8B623-3C3F-C345-8EE9-785364D7CF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27213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F2D40D-6BD3-C945-947A-7A9161E2C661}" type="datetimeFigureOut">
              <a:rPr lang="en-US" smtClean="0"/>
              <a:t>12/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8B623-3C3F-C345-8EE9-785364D7CF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92465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F2D40D-6BD3-C945-947A-7A9161E2C661}" type="datetimeFigureOut">
              <a:rPr lang="en-US" smtClean="0"/>
              <a:t>12/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8B623-3C3F-C345-8EE9-785364D7CF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10701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F2D40D-6BD3-C945-947A-7A9161E2C661}" type="datetimeFigureOut">
              <a:rPr lang="en-US" smtClean="0"/>
              <a:t>12/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8B623-3C3F-C345-8EE9-785364D7CF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24581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F2D40D-6BD3-C945-947A-7A9161E2C661}" type="datetimeFigureOut">
              <a:rPr lang="en-US" smtClean="0"/>
              <a:t>12/3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8B623-3C3F-C345-8EE9-785364D7CF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2730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F2D40D-6BD3-C945-947A-7A9161E2C661}" type="datetimeFigureOut">
              <a:rPr lang="en-US" smtClean="0"/>
              <a:t>12/3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8B623-3C3F-C345-8EE9-785364D7CF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19457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F2D40D-6BD3-C945-947A-7A9161E2C661}" type="datetimeFigureOut">
              <a:rPr lang="en-US" smtClean="0"/>
              <a:t>12/3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8B623-3C3F-C345-8EE9-785364D7CF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83705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F2D40D-6BD3-C945-947A-7A9161E2C661}" type="datetimeFigureOut">
              <a:rPr lang="en-US" smtClean="0"/>
              <a:t>12/3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8B623-3C3F-C345-8EE9-785364D7CF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48120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F2D40D-6BD3-C945-947A-7A9161E2C661}" type="datetimeFigureOut">
              <a:rPr lang="en-US" smtClean="0"/>
              <a:t>12/3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8B623-3C3F-C345-8EE9-785364D7CF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55445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F2D40D-6BD3-C945-947A-7A9161E2C661}" type="datetimeFigureOut">
              <a:rPr lang="en-US" smtClean="0"/>
              <a:t>12/3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8B623-3C3F-C345-8EE9-785364D7CF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10863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F2D40D-6BD3-C945-947A-7A9161E2C661}" type="datetimeFigureOut">
              <a:rPr lang="en-US" smtClean="0"/>
              <a:t>12/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C8B623-3C3F-C345-8EE9-785364D7CF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52372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AC62A408-CAF5-3448-BBEB-8C55A034884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66834800"/>
              </p:ext>
            </p:extLst>
          </p:nvPr>
        </p:nvGraphicFramePr>
        <p:xfrm>
          <a:off x="766601" y="856897"/>
          <a:ext cx="5559222" cy="4849952"/>
        </p:xfrm>
        <a:graphic>
          <a:graphicData uri="http://schemas.openxmlformats.org/drawingml/2006/table">
            <a:tbl>
              <a:tblPr firstRow="1">
                <a:tableStyleId>{9D7B26C5-4107-4FEC-AEDC-1716B250A1EF}</a:tableStyleId>
              </a:tblPr>
              <a:tblGrid>
                <a:gridCol w="108054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0115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5829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95036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788342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980529">
                  <a:extLst>
                    <a:ext uri="{9D8B030D-6E8A-4147-A177-3AD203B41FA5}">
                      <a16:colId xmlns:a16="http://schemas.microsoft.com/office/drawing/2014/main" val="2540416509"/>
                    </a:ext>
                  </a:extLst>
                </a:gridCol>
              </a:tblGrid>
              <a:tr h="400808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me</a:t>
                      </a:r>
                      <a:endParaRPr lang="en-US" sz="1000" b="1" dirty="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w read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pped left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pped right</a:t>
                      </a:r>
                      <a:endParaRPr lang="en-US" sz="1000" dirty="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pping rate</a:t>
                      </a:r>
                      <a:endParaRPr lang="en-US" sz="1000" dirty="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宋体" charset="-122"/>
                          <a:cs typeface="Arial" panose="020B0604020202020204" pitchFamily="34" charset="0"/>
                        </a:rPr>
                        <a:t>SRA</a:t>
                      </a:r>
                      <a:r>
                        <a:rPr lang="zh-CN" altLang="en-US" sz="1000" dirty="0">
                          <a:effectLst/>
                          <a:latin typeface="Arial" panose="020B0604020202020204" pitchFamily="34" charset="0"/>
                          <a:ea typeface="宋体" charset="-122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altLang="zh-CN" sz="1000" dirty="0">
                          <a:effectLst/>
                          <a:latin typeface="Arial" panose="020B0604020202020204" pitchFamily="34" charset="0"/>
                          <a:ea typeface="宋体" charset="-122"/>
                          <a:cs typeface="Arial" panose="020B0604020202020204" pitchFamily="34" charset="0"/>
                        </a:rPr>
                        <a:t>ID</a:t>
                      </a:r>
                      <a:endParaRPr lang="en-US" sz="1000" dirty="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17796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 WT rep1</a:t>
                      </a:r>
                      <a:endParaRPr lang="en-US" sz="1000" b="1" dirty="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,896,424*2</a:t>
                      </a:r>
                      <a:endParaRPr lang="en-US" sz="1000" dirty="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s-I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,727,784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cs-CZ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,673,683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3.4%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宋体" charset="-122"/>
                          <a:cs typeface="Arial" panose="020B0604020202020204" pitchFamily="34" charset="0"/>
                        </a:rPr>
                        <a:t>SRR13091545</a:t>
                      </a:r>
                    </a:p>
                  </a:txBody>
                  <a:tcPr marL="59258" marR="59258" marT="29629" marB="29629"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17796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 WT rep2</a:t>
                      </a:r>
                      <a:endParaRPr lang="en-US" sz="1000" b="1" dirty="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,588,822*2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s-I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,296,934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s-I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,473,33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.4%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宋体" charset="-122"/>
                          <a:cs typeface="Arial" panose="020B0604020202020204" pitchFamily="34" charset="0"/>
                        </a:rPr>
                        <a:t>SRR13091544</a:t>
                      </a:r>
                    </a:p>
                  </a:txBody>
                  <a:tcPr marL="59258" marR="59258" marT="29629" marB="29629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17796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 </a:t>
                      </a:r>
                      <a:r>
                        <a:rPr lang="en-US" sz="1000" b="1" i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sh4</a:t>
                      </a: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rep1</a:t>
                      </a:r>
                      <a:endParaRPr lang="en-US" sz="1000" b="1" dirty="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,654,140*2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s-I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,861,094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s-I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,172,603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.1%</a:t>
                      </a:r>
                      <a:endParaRPr lang="en-US" sz="1000" dirty="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宋体" charset="-122"/>
                          <a:cs typeface="Arial" panose="020B0604020202020204" pitchFamily="34" charset="0"/>
                        </a:rPr>
                        <a:t>SRR13091541</a:t>
                      </a:r>
                    </a:p>
                  </a:txBody>
                  <a:tcPr marL="59258" marR="59258" marT="29629" marB="29629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17796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 </a:t>
                      </a:r>
                      <a:r>
                        <a:rPr lang="en-US" sz="1000" b="1" i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sh4</a:t>
                      </a: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rep2</a:t>
                      </a:r>
                      <a:endParaRPr lang="en-US" sz="1000" b="1" dirty="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,676,942*2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s-I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,876,015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i-FI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,855,455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1.7%</a:t>
                      </a:r>
                      <a:endParaRPr lang="en-US" sz="1000" dirty="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宋体" charset="-122"/>
                          <a:cs typeface="Arial" panose="020B0604020202020204" pitchFamily="34" charset="0"/>
                        </a:rPr>
                        <a:t>SRR13091540</a:t>
                      </a:r>
                    </a:p>
                  </a:txBody>
                  <a:tcPr marL="59258" marR="59258" marT="29629" marB="29629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17796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 </a:t>
                      </a:r>
                      <a:r>
                        <a:rPr lang="en-US" sz="1000" b="1" i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s81</a:t>
                      </a: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rep1</a:t>
                      </a:r>
                      <a:endParaRPr lang="en-US" sz="1000" b="1" dirty="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,181,110*2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s-I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,105,363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s-I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,846,759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.5%</a:t>
                      </a:r>
                      <a:endParaRPr lang="en-US" sz="1000" dirty="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宋体" charset="-122"/>
                          <a:cs typeface="Arial" panose="020B0604020202020204" pitchFamily="34" charset="0"/>
                        </a:rPr>
                        <a:t>SRR13091539</a:t>
                      </a:r>
                    </a:p>
                  </a:txBody>
                  <a:tcPr marL="59258" marR="59258" marT="29629" marB="29629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17796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 </a:t>
                      </a:r>
                      <a:r>
                        <a:rPr lang="en-US" sz="1000" b="1" i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s81</a:t>
                      </a: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rep2</a:t>
                      </a:r>
                      <a:endParaRPr lang="en-US" sz="1000" b="1" dirty="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,907,819*2</a:t>
                      </a:r>
                      <a:endParaRPr lang="en-US" sz="1000" dirty="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s-I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,847,178</a:t>
                      </a:r>
                      <a:endParaRPr lang="en-US" sz="1000" dirty="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s-I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,651,975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.3%</a:t>
                      </a:r>
                      <a:endParaRPr lang="en-US" sz="1000" dirty="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宋体" charset="-122"/>
                          <a:cs typeface="Arial" panose="020B0604020202020204" pitchFamily="34" charset="0"/>
                        </a:rPr>
                        <a:t>SRR13091538</a:t>
                      </a:r>
                    </a:p>
                  </a:txBody>
                  <a:tcPr marL="59258" marR="59258" marT="29629" marB="29629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17796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 WT rep1</a:t>
                      </a:r>
                      <a:endParaRPr lang="en-US" sz="1000" b="1" dirty="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,488,386*2</a:t>
                      </a:r>
                      <a:endParaRPr lang="en-US" sz="1000" dirty="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cs-CZ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,385,436</a:t>
                      </a:r>
                      <a:endParaRPr lang="en-US" sz="1000" dirty="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s-I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,811,865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.2%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宋体" charset="-122"/>
                          <a:cs typeface="Arial" panose="020B0604020202020204" pitchFamily="34" charset="0"/>
                        </a:rPr>
                        <a:t>SRR13091537</a:t>
                      </a:r>
                    </a:p>
                  </a:txBody>
                  <a:tcPr marL="59258" marR="59258" marT="29629" marB="29629" anchor="ctr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17796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 WT rep2</a:t>
                      </a:r>
                      <a:endParaRPr lang="en-US" sz="1000" b="1" dirty="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,848,787*2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s-I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,815,880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s-I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,654,424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.7%</a:t>
                      </a:r>
                      <a:endParaRPr lang="en-US" sz="1000" dirty="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宋体" charset="-122"/>
                          <a:cs typeface="Arial" panose="020B0604020202020204" pitchFamily="34" charset="0"/>
                        </a:rPr>
                        <a:t>SRR13091536</a:t>
                      </a:r>
                    </a:p>
                  </a:txBody>
                  <a:tcPr marL="59258" marR="59258" marT="29629" marB="29629" anchor="ctr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317796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 </a:t>
                      </a:r>
                      <a:r>
                        <a:rPr lang="en-US" sz="1000" b="1" i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sh4</a:t>
                      </a: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rep1</a:t>
                      </a:r>
                      <a:endParaRPr lang="en-US" sz="1000" b="1" dirty="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,346,119*2</a:t>
                      </a:r>
                      <a:endParaRPr lang="en-US" sz="1000" dirty="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cs-CZ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,935,259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s-I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,881,763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.4%</a:t>
                      </a:r>
                      <a:endParaRPr lang="en-US" sz="1000" dirty="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宋体" charset="-122"/>
                          <a:cs typeface="Arial" panose="020B0604020202020204" pitchFamily="34" charset="0"/>
                        </a:rPr>
                        <a:t>SRR13091535</a:t>
                      </a:r>
                    </a:p>
                  </a:txBody>
                  <a:tcPr marL="59258" marR="59258" marT="29629" marB="29629" anchor="ctr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317796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 </a:t>
                      </a:r>
                      <a:r>
                        <a:rPr lang="en-US" sz="1000" b="1" i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sh4</a:t>
                      </a: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rep2</a:t>
                      </a:r>
                      <a:endParaRPr lang="en-US" sz="1000" b="1" dirty="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,091,147*2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s-I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,132,748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s-IS" sz="10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,211,434</a:t>
                      </a:r>
                      <a:endParaRPr lang="en-US" sz="100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.7%</a:t>
                      </a:r>
                      <a:endParaRPr lang="en-US" sz="1000" dirty="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宋体" charset="-122"/>
                          <a:cs typeface="Arial" panose="020B0604020202020204" pitchFamily="34" charset="0"/>
                        </a:rPr>
                        <a:t>SRR13091534</a:t>
                      </a:r>
                    </a:p>
                  </a:txBody>
                  <a:tcPr marL="59258" marR="59258" marT="29629" marB="29629" anchor="ctr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317796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 </a:t>
                      </a:r>
                      <a:r>
                        <a:rPr lang="en-US" sz="1000" b="1" i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us81</a:t>
                      </a: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rep2</a:t>
                      </a:r>
                      <a:endParaRPr lang="en-US" sz="1000" b="1" dirty="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,437,225*2</a:t>
                      </a:r>
                      <a:endParaRPr lang="en-US" sz="1000" dirty="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s-I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,491,354</a:t>
                      </a:r>
                      <a:endParaRPr lang="en-US" sz="1000" dirty="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is-I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,597,467</a:t>
                      </a:r>
                      <a:endParaRPr lang="en-US" sz="1000" dirty="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.6%</a:t>
                      </a:r>
                      <a:endParaRPr lang="en-US" sz="1000" dirty="0">
                        <a:effectLst/>
                        <a:latin typeface="Arial" panose="020B0604020202020204" pitchFamily="34" charset="0"/>
                        <a:ea typeface="宋体" charset="-122"/>
                        <a:cs typeface="Arial" panose="020B0604020202020204" pitchFamily="34" charset="0"/>
                      </a:endParaRP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宋体" charset="-122"/>
                          <a:cs typeface="Arial" panose="020B0604020202020204" pitchFamily="34" charset="0"/>
                        </a:rPr>
                        <a:t>SRR13091543</a:t>
                      </a:r>
                    </a:p>
                  </a:txBody>
                  <a:tcPr marL="59258" marR="59258" marT="29629" marB="29629" anchor="ctr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317796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宋体" charset="-122"/>
                          <a:cs typeface="Arial" panose="020B0604020202020204" pitchFamily="34" charset="0"/>
                        </a:rPr>
                        <a:t>28 </a:t>
                      </a:r>
                      <a:r>
                        <a:rPr lang="en-US" sz="1000" b="1" i="1" dirty="0">
                          <a:effectLst/>
                          <a:latin typeface="Arial" panose="020B0604020202020204" pitchFamily="34" charset="0"/>
                          <a:ea typeface="宋体" charset="-122"/>
                          <a:cs typeface="Arial" panose="020B0604020202020204" pitchFamily="34" charset="0"/>
                        </a:rPr>
                        <a:t>mus81</a:t>
                      </a: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宋体" charset="-122"/>
                          <a:cs typeface="Arial" panose="020B0604020202020204" pitchFamily="34" charset="0"/>
                        </a:rPr>
                        <a:t> rep4</a:t>
                      </a: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dirty="0">
                          <a:effectLst/>
                          <a:latin typeface="Arial" panose="020B0604020202020204" pitchFamily="34" charset="0"/>
                          <a:ea typeface="宋体" charset="-122"/>
                          <a:cs typeface="Arial" panose="020B0604020202020204" pitchFamily="34" charset="0"/>
                        </a:rPr>
                        <a:t>29,068,783*2</a:t>
                      </a: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宋体" charset="-122"/>
                          <a:cs typeface="Arial" panose="020B0604020202020204" pitchFamily="34" charset="0"/>
                        </a:rPr>
                        <a:t>27,589,126</a:t>
                      </a: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宋体" charset="-122"/>
                          <a:cs typeface="Arial" panose="020B0604020202020204" pitchFamily="34" charset="0"/>
                        </a:rPr>
                        <a:t>26,462,933</a:t>
                      </a: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宋体" charset="-122"/>
                          <a:cs typeface="Arial" panose="020B0604020202020204" pitchFamily="34" charset="0"/>
                        </a:rPr>
                        <a:t>96.4%</a:t>
                      </a: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宋体" charset="-122"/>
                          <a:cs typeface="Arial" panose="020B0604020202020204" pitchFamily="34" charset="0"/>
                        </a:rPr>
                        <a:t>SRR13091542</a:t>
                      </a:r>
                    </a:p>
                  </a:txBody>
                  <a:tcPr marL="59258" marR="59258" marT="29629" marB="29629" anchor="ctr"/>
                </a:tc>
                <a:extLst>
                  <a:ext uri="{0D108BD9-81ED-4DB2-BD59-A6C34878D82A}">
                    <a16:rowId xmlns:a16="http://schemas.microsoft.com/office/drawing/2014/main" val="3205289204"/>
                  </a:ext>
                </a:extLst>
              </a:tr>
              <a:tr h="317796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宋体" charset="-122"/>
                          <a:cs typeface="Arial" panose="020B0604020202020204" pitchFamily="34" charset="0"/>
                        </a:rPr>
                        <a:t>20 WT leaf rep1</a:t>
                      </a: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dirty="0">
                          <a:effectLst/>
                          <a:latin typeface="Arial" panose="020B0604020202020204" pitchFamily="34" charset="0"/>
                          <a:ea typeface="宋体" charset="-122"/>
                          <a:cs typeface="Arial" panose="020B0604020202020204" pitchFamily="34" charset="0"/>
                        </a:rPr>
                        <a:t>35,586,241*2</a:t>
                      </a: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宋体" charset="-122"/>
                          <a:cs typeface="Arial" panose="020B0604020202020204" pitchFamily="34" charset="0"/>
                        </a:rPr>
                        <a:t>33,087,044</a:t>
                      </a: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宋体" charset="-122"/>
                          <a:cs typeface="Arial" panose="020B0604020202020204" pitchFamily="34" charset="0"/>
                        </a:rPr>
                        <a:t>30,093,260</a:t>
                      </a: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宋体" charset="-122"/>
                          <a:cs typeface="Arial" panose="020B0604020202020204" pitchFamily="34" charset="0"/>
                        </a:rPr>
                        <a:t>88.8%</a:t>
                      </a: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宋体" charset="-122"/>
                          <a:cs typeface="Arial" panose="020B0604020202020204" pitchFamily="34" charset="0"/>
                        </a:rPr>
                        <a:t>SRR8352560</a:t>
                      </a:r>
                    </a:p>
                  </a:txBody>
                  <a:tcPr marL="59258" marR="59258" marT="29629" marB="29629" anchor="ctr"/>
                </a:tc>
                <a:extLst>
                  <a:ext uri="{0D108BD9-81ED-4DB2-BD59-A6C34878D82A}">
                    <a16:rowId xmlns:a16="http://schemas.microsoft.com/office/drawing/2014/main" val="2047034087"/>
                  </a:ext>
                </a:extLst>
              </a:tr>
              <a:tr h="317796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dirty="0">
                          <a:effectLst/>
                          <a:latin typeface="Arial" panose="020B0604020202020204" pitchFamily="34" charset="0"/>
                          <a:ea typeface="宋体" charset="-122"/>
                          <a:cs typeface="Arial" panose="020B0604020202020204" pitchFamily="34" charset="0"/>
                        </a:rPr>
                        <a:t>20 WT leaf rep2</a:t>
                      </a: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dirty="0">
                          <a:effectLst/>
                          <a:latin typeface="Arial" panose="020B0604020202020204" pitchFamily="34" charset="0"/>
                          <a:ea typeface="宋体" charset="-122"/>
                          <a:cs typeface="Arial" panose="020B0604020202020204" pitchFamily="34" charset="0"/>
                        </a:rPr>
                        <a:t>27,799,322*2</a:t>
                      </a: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宋体" charset="-122"/>
                          <a:cs typeface="Arial" panose="020B0604020202020204" pitchFamily="34" charset="0"/>
                        </a:rPr>
                        <a:t>25,749,307</a:t>
                      </a: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宋体" charset="-122"/>
                          <a:cs typeface="Arial" panose="020B0604020202020204" pitchFamily="34" charset="0"/>
                        </a:rPr>
                        <a:t>23,482,777</a:t>
                      </a: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宋体" charset="-122"/>
                          <a:cs typeface="Arial" panose="020B0604020202020204" pitchFamily="34" charset="0"/>
                        </a:rPr>
                        <a:t>88.6%</a:t>
                      </a:r>
                    </a:p>
                  </a:txBody>
                  <a:tcPr marL="59258" marR="59258" marT="29629" marB="29629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dirty="0">
                          <a:effectLst/>
                          <a:latin typeface="Arial" panose="020B0604020202020204" pitchFamily="34" charset="0"/>
                          <a:ea typeface="宋体" charset="-122"/>
                          <a:cs typeface="Arial" panose="020B0604020202020204" pitchFamily="34" charset="0"/>
                        </a:rPr>
                        <a:t>SRR8352561</a:t>
                      </a:r>
                    </a:p>
                  </a:txBody>
                  <a:tcPr marL="59258" marR="59258" marT="29629" marB="29629" anchor="ctr"/>
                </a:tc>
                <a:extLst>
                  <a:ext uri="{0D108BD9-81ED-4DB2-BD59-A6C34878D82A}">
                    <a16:rowId xmlns:a16="http://schemas.microsoft.com/office/drawing/2014/main" val="2501638766"/>
                  </a:ext>
                </a:extLst>
              </a:tr>
            </a:tbl>
          </a:graphicData>
        </a:graphic>
      </p:graphicFrame>
      <p:sp>
        <p:nvSpPr>
          <p:cNvPr id="4" name="Rectangle 3">
            <a:extLst>
              <a:ext uri="{FF2B5EF4-FFF2-40B4-BE49-F238E27FC236}">
                <a16:creationId xmlns:a16="http://schemas.microsoft.com/office/drawing/2014/main" id="{25F345BD-6D2D-E849-81FE-A91BF30DD048}"/>
              </a:ext>
            </a:extLst>
          </p:cNvPr>
          <p:cNvSpPr/>
          <p:nvPr/>
        </p:nvSpPr>
        <p:spPr>
          <a:xfrm>
            <a:off x="5279096" y="123153"/>
            <a:ext cx="161775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1 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4D2249B2-666F-E149-B348-F3D846763147}"/>
              </a:ext>
            </a:extLst>
          </p:cNvPr>
          <p:cNvSpPr/>
          <p:nvPr/>
        </p:nvSpPr>
        <p:spPr>
          <a:xfrm>
            <a:off x="991421" y="490241"/>
            <a:ext cx="5887844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1 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haracteristics of the 14 RNA-Seq datasets used in the study.</a:t>
            </a:r>
          </a:p>
        </p:txBody>
      </p:sp>
    </p:spTree>
    <p:extLst>
      <p:ext uri="{BB962C8B-B14F-4D97-AF65-F5344CB8AC3E}">
        <p14:creationId xmlns:p14="http://schemas.microsoft.com/office/powerpoint/2010/main" val="20843005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7867</TotalTime>
  <Words>157</Words>
  <Application>Microsoft Macintosh PowerPoint</Application>
  <PresentationFormat>A4 Paper (210x297 mm)</PresentationFormat>
  <Paragraphs>9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ple Braille</vt:lpstr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uang Jeff</dc:creator>
  <cp:lastModifiedBy>Huang Jeff</cp:lastModifiedBy>
  <cp:revision>208</cp:revision>
  <cp:lastPrinted>2020-11-24T21:15:37Z</cp:lastPrinted>
  <dcterms:created xsi:type="dcterms:W3CDTF">2018-06-06T18:52:07Z</dcterms:created>
  <dcterms:modified xsi:type="dcterms:W3CDTF">2020-12-03T19:00:12Z</dcterms:modified>
</cp:coreProperties>
</file>